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DC60B63-D763-49A9-A65F-809A657EDB1D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B92403A-0473-4BCE-9758-2296EEE141DB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4380CE9-3976-4C64-884C-5B9C5716E18D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3313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594144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685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/>
          </p:nvPr>
        </p:nvSpPr>
        <p:spPr>
          <a:xfrm>
            <a:off x="3313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/>
          </p:nvPr>
        </p:nvSpPr>
        <p:spPr>
          <a:xfrm>
            <a:off x="594144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19E94B6-2FCD-4BF2-B35D-EF0E6155157B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F53B62A-2EE8-487B-A81C-CF05DBEDADA8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0C36008-5FCF-40FB-BB89-7FE59A93CE06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A5E3475-A6C6-47B4-BFE7-1A180722F46C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E77E1B0-EB62-41AA-945E-F05D0A3ABA48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685800" y="380520"/>
            <a:ext cx="7772400" cy="741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F81B3CF-0319-4B5A-A7BC-598A752C1E25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3ABE871-1118-4984-B3F5-C4ECD2C05430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A758657-F0C6-46DB-84F9-0954E3CDC3E0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DCC4A8B-DA22-4FB9-A155-65692A1D7BE2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826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188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840" indent="-22860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9040" indent="-2286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1"/>
          </p:nvPr>
        </p:nvSpPr>
        <p:spPr>
          <a:xfrm>
            <a:off x="7348680" y="6248520"/>
            <a:ext cx="312480" cy="30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 anchorCtr="1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82A058-7E2B-4794-8DD4-5E7086CD59EA}" type="slidenum"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Rectangle 1"/>
          <p:cNvSpPr/>
          <p:nvPr/>
        </p:nvSpPr>
        <p:spPr>
          <a:xfrm>
            <a:off x="685800" y="609480"/>
            <a:ext cx="693432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40680" tIns="0" bIns="0" anchor="t">
            <a:spAutoFit/>
          </a:bodyPr>
          <a:p>
            <a:pPr marL="396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dditional file 1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5. MeDIP/NimbleGen Promoter + CpGi Array: Analysis of RLGS T-DMR loci by MeDI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0" name="Group 37"/>
          <p:cNvGrpSpPr/>
          <p:nvPr/>
        </p:nvGrpSpPr>
        <p:grpSpPr>
          <a:xfrm>
            <a:off x="685800" y="1752480"/>
            <a:ext cx="7543800" cy="4648320"/>
            <a:chOff x="685800" y="1752480"/>
            <a:chExt cx="7543800" cy="4648320"/>
          </a:xfrm>
        </p:grpSpPr>
        <p:pic>
          <p:nvPicPr>
            <p:cNvPr id="41" name="Picture 44" descr=""/>
            <p:cNvPicPr/>
            <p:nvPr/>
          </p:nvPicPr>
          <p:blipFill>
            <a:blip r:embed="rId1"/>
            <a:srcRect l="53907" t="14280" r="20311" b="29797"/>
            <a:stretch/>
          </p:blipFill>
          <p:spPr>
            <a:xfrm>
              <a:off x="3292920" y="2603520"/>
              <a:ext cx="1414440" cy="3797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2" name="Rectangle 2"/>
            <p:cNvSpPr/>
            <p:nvPr/>
          </p:nvSpPr>
          <p:spPr>
            <a:xfrm>
              <a:off x="1144080" y="1752480"/>
              <a:ext cx="935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cus/Ch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4"/>
            <p:cNvSpPr/>
            <p:nvPr/>
          </p:nvSpPr>
          <p:spPr>
            <a:xfrm>
              <a:off x="1173600" y="2566080"/>
              <a:ext cx="994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pG islan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5"/>
            <p:cNvSpPr/>
            <p:nvPr/>
          </p:nvSpPr>
          <p:spPr>
            <a:xfrm>
              <a:off x="1254960" y="2888280"/>
              <a:ext cx="913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nscrip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6"/>
            <p:cNvSpPr/>
            <p:nvPr/>
          </p:nvSpPr>
          <p:spPr>
            <a:xfrm>
              <a:off x="685800" y="3327120"/>
              <a:ext cx="1482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Arial"/>
                  <a:ea typeface="Arial"/>
                </a:rPr>
                <a:t>Scaled log2 rati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7"/>
            <p:cNvSpPr/>
            <p:nvPr/>
          </p:nvSpPr>
          <p:spPr>
            <a:xfrm>
              <a:off x="1615680" y="3590640"/>
              <a:ext cx="624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iver 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8"/>
            <p:cNvSpPr/>
            <p:nvPr/>
          </p:nvSpPr>
          <p:spPr>
            <a:xfrm>
              <a:off x="1608480" y="4101120"/>
              <a:ext cx="626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iver 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9"/>
            <p:cNvSpPr/>
            <p:nvPr/>
          </p:nvSpPr>
          <p:spPr>
            <a:xfrm>
              <a:off x="1519560" y="4611600"/>
              <a:ext cx="702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estis 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0"/>
            <p:cNvSpPr/>
            <p:nvPr/>
          </p:nvSpPr>
          <p:spPr>
            <a:xfrm>
              <a:off x="1793160" y="5640120"/>
              <a:ext cx="436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S 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1"/>
            <p:cNvSpPr/>
            <p:nvPr/>
          </p:nvSpPr>
          <p:spPr>
            <a:xfrm>
              <a:off x="1793160" y="6091920"/>
              <a:ext cx="436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S 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8"/>
            <p:cNvSpPr/>
            <p:nvPr/>
          </p:nvSpPr>
          <p:spPr>
            <a:xfrm>
              <a:off x="2346120" y="1752480"/>
              <a:ext cx="883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st4/Chr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9"/>
            <p:cNvSpPr/>
            <p:nvPr/>
          </p:nvSpPr>
          <p:spPr>
            <a:xfrm>
              <a:off x="3636720" y="1752480"/>
              <a:ext cx="1083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st10/Chr1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20"/>
            <p:cNvSpPr/>
            <p:nvPr/>
          </p:nvSpPr>
          <p:spPr>
            <a:xfrm>
              <a:off x="5256360" y="1752480"/>
              <a:ext cx="933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vu4/Chr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21"/>
            <p:cNvSpPr/>
            <p:nvPr/>
          </p:nvSpPr>
          <p:spPr>
            <a:xfrm>
              <a:off x="7020360" y="1752480"/>
              <a:ext cx="933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vu5/Chr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27"/>
            <p:cNvSpPr/>
            <p:nvPr/>
          </p:nvSpPr>
          <p:spPr>
            <a:xfrm>
              <a:off x="2538360" y="2204280"/>
              <a:ext cx="684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esp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28"/>
            <p:cNvSpPr/>
            <p:nvPr/>
          </p:nvSpPr>
          <p:spPr>
            <a:xfrm>
              <a:off x="1582560" y="2202480"/>
              <a:ext cx="497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29"/>
            <p:cNvSpPr/>
            <p:nvPr/>
          </p:nvSpPr>
          <p:spPr>
            <a:xfrm>
              <a:off x="3832560" y="2204280"/>
              <a:ext cx="624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Zfp20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30"/>
            <p:cNvSpPr/>
            <p:nvPr/>
          </p:nvSpPr>
          <p:spPr>
            <a:xfrm>
              <a:off x="5389560" y="2204280"/>
              <a:ext cx="624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Zfp32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31"/>
            <p:cNvSpPr/>
            <p:nvPr/>
          </p:nvSpPr>
          <p:spPr>
            <a:xfrm>
              <a:off x="7161120" y="2204280"/>
              <a:ext cx="624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Zfp7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32"/>
            <p:cNvSpPr/>
            <p:nvPr/>
          </p:nvSpPr>
          <p:spPr>
            <a:xfrm>
              <a:off x="1539720" y="5122080"/>
              <a:ext cx="7005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0680" tIns="0" bIns="0" anchor="t">
              <a:spAutoFit/>
            </a:bodyPr>
            <a:p>
              <a:pPr marL="39600"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estis 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34"/>
            <p:cNvSpPr/>
            <p:nvPr/>
          </p:nvSpPr>
          <p:spPr>
            <a:xfrm>
              <a:off x="3170880" y="2603520"/>
              <a:ext cx="46080" cy="3797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35"/>
            <p:cNvSpPr/>
            <p:nvPr/>
          </p:nvSpPr>
          <p:spPr>
            <a:xfrm flipH="1">
              <a:off x="6500880" y="2603520"/>
              <a:ext cx="42480" cy="3797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36"/>
            <p:cNvSpPr/>
            <p:nvPr/>
          </p:nvSpPr>
          <p:spPr>
            <a:xfrm>
              <a:off x="4679640" y="2603520"/>
              <a:ext cx="46080" cy="3797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37"/>
            <p:cNvSpPr/>
            <p:nvPr/>
          </p:nvSpPr>
          <p:spPr>
            <a:xfrm>
              <a:off x="8183520" y="2603520"/>
              <a:ext cx="46080" cy="3797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5" name="Picture 38" descr=""/>
            <p:cNvPicPr/>
            <p:nvPr/>
          </p:nvPicPr>
          <p:blipFill>
            <a:blip r:embed="rId2"/>
            <a:srcRect l="70316" t="14280" r="17967" b="31126"/>
            <a:stretch/>
          </p:blipFill>
          <p:spPr>
            <a:xfrm>
              <a:off x="2507040" y="2603520"/>
              <a:ext cx="650520" cy="3706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Line 39"/>
            <p:cNvSpPr/>
            <p:nvPr/>
          </p:nvSpPr>
          <p:spPr>
            <a:xfrm flipH="1">
              <a:off x="2457000" y="2916360"/>
              <a:ext cx="218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40"/>
            <p:cNvSpPr/>
            <p:nvPr/>
          </p:nvSpPr>
          <p:spPr>
            <a:xfrm flipH="1" flipV="1">
              <a:off x="2682360" y="2912760"/>
              <a:ext cx="5400" cy="16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8" name="Picture 41" descr=""/>
            <p:cNvPicPr/>
            <p:nvPr/>
          </p:nvPicPr>
          <p:blipFill>
            <a:blip r:embed="rId3"/>
            <a:srcRect l="49219" t="14280" r="7811" b="31126"/>
            <a:stretch/>
          </p:blipFill>
          <p:spPr>
            <a:xfrm>
              <a:off x="4772160" y="2603520"/>
              <a:ext cx="1739880" cy="3706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Line 42"/>
            <p:cNvSpPr/>
            <p:nvPr/>
          </p:nvSpPr>
          <p:spPr>
            <a:xfrm flipV="1">
              <a:off x="5128200" y="2916000"/>
              <a:ext cx="1800" cy="203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43"/>
            <p:cNvSpPr/>
            <p:nvPr/>
          </p:nvSpPr>
          <p:spPr>
            <a:xfrm>
              <a:off x="5128920" y="2916360"/>
              <a:ext cx="218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45"/>
            <p:cNvSpPr/>
            <p:nvPr/>
          </p:nvSpPr>
          <p:spPr>
            <a:xfrm flipV="1">
              <a:off x="3390120" y="2844720"/>
              <a:ext cx="1800" cy="205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46"/>
            <p:cNvSpPr/>
            <p:nvPr/>
          </p:nvSpPr>
          <p:spPr>
            <a:xfrm>
              <a:off x="3390840" y="2844720"/>
              <a:ext cx="218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3" name="Picture 47" descr=""/>
            <p:cNvPicPr/>
            <p:nvPr/>
          </p:nvPicPr>
          <p:blipFill>
            <a:blip r:embed="rId4"/>
            <a:srcRect l="43752" t="12937" r="11717" b="31217"/>
            <a:stretch/>
          </p:blipFill>
          <p:spPr>
            <a:xfrm>
              <a:off x="6609960" y="2513160"/>
              <a:ext cx="1577160" cy="3797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" name="Line 48"/>
            <p:cNvSpPr/>
            <p:nvPr/>
          </p:nvSpPr>
          <p:spPr>
            <a:xfrm flipV="1">
              <a:off x="6855120" y="2835000"/>
              <a:ext cx="1800" cy="203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49"/>
            <p:cNvSpPr/>
            <p:nvPr/>
          </p:nvSpPr>
          <p:spPr>
            <a:xfrm>
              <a:off x="6855840" y="2835360"/>
              <a:ext cx="218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4T18:24:34Z</dcterms:created>
  <dc:creator>william held</dc:creator>
  <dc:description/>
  <dc:language>en-US</dc:language>
  <cp:lastModifiedBy>Hiroki</cp:lastModifiedBy>
  <cp:lastPrinted>2010-05-04T17:44:22Z</cp:lastPrinted>
  <dcterms:modified xsi:type="dcterms:W3CDTF">2011-05-06T13:50:53Z</dcterms:modified>
  <cp:revision>75</cp:revision>
  <dc:subject/>
  <dc:title>PowerPoint Presentation</dc:title>
</cp:coreProperties>
</file>